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0" d="100"/>
          <a:sy n="100" d="100"/>
        </p:scale>
        <p:origin x="-156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791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524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64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755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045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52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999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7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075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2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311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171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"/>
          <p:cNvSpPr txBox="1">
            <a:spLocks noChangeArrowheads="1"/>
          </p:cNvSpPr>
          <p:nvPr/>
        </p:nvSpPr>
        <p:spPr bwMode="auto">
          <a:xfrm>
            <a:off x="103188" y="718344"/>
            <a:ext cx="2286000" cy="636587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chemeClr val="bg1"/>
                </a:solidFill>
                <a:cs typeface="Arial" charset="0"/>
              </a:rPr>
              <a:t>4D  DCE MRI images</a:t>
            </a:r>
          </a:p>
        </p:txBody>
      </p:sp>
      <p:sp>
        <p:nvSpPr>
          <p:cNvPr id="4" name="TextBox 2"/>
          <p:cNvSpPr txBox="1">
            <a:spLocks noChangeArrowheads="1"/>
          </p:cNvSpPr>
          <p:nvPr/>
        </p:nvSpPr>
        <p:spPr bwMode="auto">
          <a:xfrm>
            <a:off x="1593850" y="2964656"/>
            <a:ext cx="5951538" cy="358775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 b="1">
                <a:solidFill>
                  <a:schemeClr val="bg1"/>
                </a:solidFill>
                <a:cs typeface="Arial" charset="0"/>
              </a:rPr>
              <a:t>Computer-Extracted Image Phenotypes (CEIP)</a:t>
            </a:r>
          </a:p>
        </p:txBody>
      </p:sp>
      <p:cxnSp>
        <p:nvCxnSpPr>
          <p:cNvPr id="5" name="Straight Arrow Connector 4"/>
          <p:cNvCxnSpPr>
            <a:endCxn id="4" idx="0"/>
          </p:cNvCxnSpPr>
          <p:nvPr/>
        </p:nvCxnSpPr>
        <p:spPr>
          <a:xfrm>
            <a:off x="4568825" y="2577306"/>
            <a:ext cx="1588" cy="38735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369888" y="3885406"/>
            <a:ext cx="1066800" cy="912813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rgbClr val="FFFFFF"/>
                </a:solidFill>
                <a:cs typeface="Arial" charset="0"/>
              </a:rPr>
              <a:t>Size</a:t>
            </a: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7" name="TextBox 6"/>
          <p:cNvSpPr txBox="1">
            <a:spLocks noChangeArrowheads="1"/>
          </p:cNvSpPr>
          <p:nvPr/>
        </p:nvSpPr>
        <p:spPr bwMode="auto">
          <a:xfrm>
            <a:off x="1741488" y="3885406"/>
            <a:ext cx="914400" cy="912813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rgbClr val="FFFFFF"/>
                </a:solidFill>
                <a:cs typeface="Arial" charset="0"/>
              </a:rPr>
              <a:t>Shape</a:t>
            </a: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9" name="TextBox 7"/>
          <p:cNvSpPr txBox="1">
            <a:spLocks noChangeArrowheads="1"/>
          </p:cNvSpPr>
          <p:nvPr/>
        </p:nvSpPr>
        <p:spPr bwMode="auto">
          <a:xfrm>
            <a:off x="3189288" y="3875881"/>
            <a:ext cx="1543050" cy="914400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rgbClr val="FFFFFF"/>
                </a:solidFill>
                <a:cs typeface="Arial" charset="0"/>
              </a:rPr>
              <a:t>Morphology</a:t>
            </a: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10" name="TextBox 8"/>
          <p:cNvSpPr txBox="1">
            <a:spLocks noChangeArrowheads="1"/>
          </p:cNvSpPr>
          <p:nvPr/>
        </p:nvSpPr>
        <p:spPr bwMode="auto">
          <a:xfrm>
            <a:off x="5418138" y="3866356"/>
            <a:ext cx="2971800" cy="358775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rgbClr val="FFFFFF"/>
                </a:solidFill>
                <a:cs typeface="Arial" charset="0"/>
              </a:rPr>
              <a:t>Contrast Enhancement 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288" y="4274344"/>
            <a:ext cx="723900" cy="449262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4825" y="4274344"/>
            <a:ext cx="847725" cy="373062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4213" y="4298156"/>
            <a:ext cx="1336675" cy="425450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14" name="Straight Connector 13"/>
          <p:cNvCxnSpPr/>
          <p:nvPr/>
        </p:nvCxnSpPr>
        <p:spPr>
          <a:xfrm>
            <a:off x="979488" y="3580606"/>
            <a:ext cx="5943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993775" y="3580606"/>
            <a:ext cx="0" cy="3048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2198688" y="3580606"/>
            <a:ext cx="0" cy="3048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3875088" y="3580606"/>
            <a:ext cx="0" cy="3048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6923088" y="3580606"/>
            <a:ext cx="0" cy="3048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4545013" y="3386931"/>
            <a:ext cx="0" cy="19367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22"/>
          <p:cNvSpPr txBox="1">
            <a:spLocks noChangeArrowheads="1"/>
          </p:cNvSpPr>
          <p:nvPr/>
        </p:nvSpPr>
        <p:spPr bwMode="auto">
          <a:xfrm>
            <a:off x="4941888" y="4961731"/>
            <a:ext cx="1066800" cy="914400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rgbClr val="FFFFFF"/>
                </a:solidFill>
                <a:cs typeface="Arial" charset="0"/>
              </a:rPr>
              <a:t>Texture</a:t>
            </a: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21" name="TextBox 23"/>
          <p:cNvSpPr txBox="1">
            <a:spLocks noChangeArrowheads="1"/>
          </p:cNvSpPr>
          <p:nvPr/>
        </p:nvSpPr>
        <p:spPr bwMode="auto">
          <a:xfrm>
            <a:off x="6389688" y="4971256"/>
            <a:ext cx="1066800" cy="912813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rgbClr val="FFFFFF"/>
                </a:solidFill>
                <a:cs typeface="Arial" charset="0"/>
              </a:rPr>
              <a:t>Curve</a:t>
            </a: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22" name="TextBox 24"/>
          <p:cNvSpPr txBox="1">
            <a:spLocks noChangeArrowheads="1"/>
          </p:cNvSpPr>
          <p:nvPr/>
        </p:nvSpPr>
        <p:spPr bwMode="auto">
          <a:xfrm>
            <a:off x="7837488" y="4961731"/>
            <a:ext cx="1162050" cy="914400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rgbClr val="FFFFFF"/>
                </a:solidFill>
                <a:cs typeface="Arial" charset="0"/>
              </a:rPr>
              <a:t>Variance</a:t>
            </a: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  <a:p>
            <a:pPr algn="ctr" eaLnBrk="1" hangingPunct="1"/>
            <a:endParaRPr lang="en-US" sz="1800">
              <a:solidFill>
                <a:srgbClr val="FFFFFF"/>
              </a:solidFill>
              <a:cs typeface="Arial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5475288" y="4661694"/>
            <a:ext cx="2940050" cy="4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5475288" y="4663281"/>
            <a:ext cx="0" cy="3048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6923088" y="4663281"/>
            <a:ext cx="0" cy="3048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8415338" y="4663281"/>
            <a:ext cx="0" cy="3048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5238" y="5349081"/>
            <a:ext cx="800100" cy="457200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8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26200" y="5366544"/>
            <a:ext cx="962025" cy="457200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9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37488" y="5366544"/>
            <a:ext cx="1066800" cy="508000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0" name="Picture 120" descr="t03d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0313" y="642144"/>
            <a:ext cx="930275" cy="608012"/>
          </a:xfrm>
          <a:prstGeom prst="rect">
            <a:avLst/>
          </a:prstGeom>
          <a:solidFill>
            <a:srgbClr val="0000FF"/>
          </a:solidFill>
          <a:ln w="9525">
            <a:solidFill>
              <a:srgbClr val="000000"/>
            </a:solidFill>
            <a:miter lim="800000"/>
            <a:headEnd/>
            <a:tailEnd/>
          </a:ln>
        </p:spPr>
      </p:pic>
      <p:pic>
        <p:nvPicPr>
          <p:cNvPr id="31" name="Picture 121" descr="t13d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7575" y="642144"/>
            <a:ext cx="930275" cy="608012"/>
          </a:xfrm>
          <a:prstGeom prst="rect">
            <a:avLst/>
          </a:prstGeom>
          <a:solidFill>
            <a:srgbClr val="0000FF"/>
          </a:solidFill>
          <a:ln w="9525">
            <a:solidFill>
              <a:srgbClr val="000000"/>
            </a:solidFill>
            <a:miter lim="800000"/>
            <a:headEnd/>
            <a:tailEnd/>
          </a:ln>
        </p:spPr>
      </p:pic>
      <p:pic>
        <p:nvPicPr>
          <p:cNvPr id="32" name="Picture 122" descr="t23d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4838" y="642144"/>
            <a:ext cx="957262" cy="623887"/>
          </a:xfrm>
          <a:prstGeom prst="rect">
            <a:avLst/>
          </a:prstGeom>
          <a:solidFill>
            <a:srgbClr val="0000FF"/>
          </a:solidFill>
          <a:ln w="9525">
            <a:solidFill>
              <a:srgbClr val="000000"/>
            </a:solidFill>
            <a:miter lim="800000"/>
            <a:headEnd/>
            <a:tailEnd/>
          </a:ln>
        </p:spPr>
      </p:pic>
      <p:pic>
        <p:nvPicPr>
          <p:cNvPr id="33" name="Picture 123" descr="t43d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56313" y="669131"/>
            <a:ext cx="928687" cy="606425"/>
          </a:xfrm>
          <a:prstGeom prst="rect">
            <a:avLst/>
          </a:prstGeom>
          <a:solidFill>
            <a:srgbClr val="0000FF"/>
          </a:solidFill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34" name="Text Box 124"/>
          <p:cNvSpPr txBox="1">
            <a:spLocks noChangeAspect="1" noChangeArrowheads="1"/>
          </p:cNvSpPr>
          <p:nvPr/>
        </p:nvSpPr>
        <p:spPr bwMode="auto">
          <a:xfrm>
            <a:off x="5426075" y="761206"/>
            <a:ext cx="601663" cy="266700"/>
          </a:xfrm>
          <a:prstGeom prst="rect">
            <a:avLst/>
          </a:prstGeom>
          <a:solidFill>
            <a:srgbClr val="0000FF"/>
          </a:solidFill>
          <a:ln w="9525">
            <a:solidFill>
              <a:schemeClr val="bg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defTabSz="32131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defTabSz="32131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defTabSz="32131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defTabSz="32131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defTabSz="32131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2131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2131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2131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2131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zh-CN" sz="1200">
                <a:solidFill>
                  <a:schemeClr val="bg1"/>
                </a:solidFill>
                <a:latin typeface="Helvetica" charset="0"/>
                <a:cs typeface="Arial" charset="0"/>
              </a:rPr>
              <a:t>……</a:t>
            </a:r>
          </a:p>
        </p:txBody>
      </p:sp>
      <p:sp>
        <p:nvSpPr>
          <p:cNvPr id="35" name="Rectangle 34"/>
          <p:cNvSpPr>
            <a:spLocks noChangeArrowheads="1"/>
          </p:cNvSpPr>
          <p:nvPr/>
        </p:nvSpPr>
        <p:spPr bwMode="auto">
          <a:xfrm>
            <a:off x="1774825" y="4274344"/>
            <a:ext cx="847725" cy="373062"/>
          </a:xfrm>
          <a:prstGeom prst="rect">
            <a:avLst/>
          </a:prstGeom>
          <a:solidFill>
            <a:srgbClr val="0000FF"/>
          </a:solidFill>
          <a:ln w="9525">
            <a:solidFill>
              <a:srgbClr val="B6DCDF"/>
            </a:solidFill>
            <a:miter lim="800000"/>
            <a:headEnd/>
            <a:tailEnd/>
          </a:ln>
          <a:effectLst>
            <a:outerShdw blurRad="40000" dist="23000" dir="5400000" rotWithShape="0">
              <a:srgbClr val="000000">
                <a:alpha val="34998"/>
              </a:srgbClr>
            </a:outerShdw>
          </a:effectLst>
        </p:spPr>
        <p:txBody>
          <a:bodyPr lIns="81638" tIns="40819" rIns="81638" bIns="40819" anchor="ctr"/>
          <a:lstStyle/>
          <a:p>
            <a:pPr algn="ctr">
              <a:defRPr/>
            </a:pPr>
            <a:endParaRPr lang="en-US">
              <a:solidFill>
                <a:srgbClr val="FFFFFF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36" name="Oval 35"/>
          <p:cNvSpPr>
            <a:spLocks noChangeArrowheads="1"/>
          </p:cNvSpPr>
          <p:nvPr/>
        </p:nvSpPr>
        <p:spPr bwMode="auto">
          <a:xfrm>
            <a:off x="1843088" y="4342606"/>
            <a:ext cx="250825" cy="2413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round/>
            <a:headEnd/>
            <a:tailEnd/>
          </a:ln>
          <a:effectLst>
            <a:outerShdw blurRad="40000" dist="23000" dir="5400000" rotWithShape="0">
              <a:srgbClr val="000000">
                <a:alpha val="34998"/>
              </a:srgbClr>
            </a:outerShdw>
          </a:effectLst>
        </p:spPr>
        <p:txBody>
          <a:bodyPr lIns="81638" tIns="40819" rIns="81638" bIns="40819" anchor="ctr"/>
          <a:lstStyle/>
          <a:p>
            <a:pPr algn="ctr">
              <a:defRPr/>
            </a:pPr>
            <a:endParaRPr lang="en-US">
              <a:solidFill>
                <a:srgbClr val="FFFFFF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37" name="Freeform 36"/>
          <p:cNvSpPr>
            <a:spLocks/>
          </p:cNvSpPr>
          <p:nvPr/>
        </p:nvSpPr>
        <p:spPr bwMode="auto">
          <a:xfrm>
            <a:off x="2224088" y="4329906"/>
            <a:ext cx="328612" cy="254000"/>
          </a:xfrm>
          <a:custGeom>
            <a:avLst/>
            <a:gdLst>
              <a:gd name="T0" fmla="*/ 64296 w 378471"/>
              <a:gd name="T1" fmla="*/ 472854 h 197624"/>
              <a:gd name="T2" fmla="*/ 64296 w 378471"/>
              <a:gd name="T3" fmla="*/ 472854 h 197624"/>
              <a:gd name="T4" fmla="*/ 23274 w 378471"/>
              <a:gd name="T5" fmla="*/ 441329 h 197624"/>
              <a:gd name="T6" fmla="*/ 15070 w 378471"/>
              <a:gd name="T7" fmla="*/ 378282 h 197624"/>
              <a:gd name="T8" fmla="*/ 1395 w 378471"/>
              <a:gd name="T9" fmla="*/ 409808 h 197624"/>
              <a:gd name="T10" fmla="*/ 28 w 378471"/>
              <a:gd name="T11" fmla="*/ 535907 h 197624"/>
              <a:gd name="T12" fmla="*/ 1395 w 378471"/>
              <a:gd name="T13" fmla="*/ 630476 h 197624"/>
              <a:gd name="T14" fmla="*/ 6864 w 378471"/>
              <a:gd name="T15" fmla="*/ 819616 h 197624"/>
              <a:gd name="T16" fmla="*/ 8232 w 378471"/>
              <a:gd name="T17" fmla="*/ 914187 h 197624"/>
              <a:gd name="T18" fmla="*/ 16436 w 378471"/>
              <a:gd name="T19" fmla="*/ 1040275 h 197624"/>
              <a:gd name="T20" fmla="*/ 15070 w 378471"/>
              <a:gd name="T21" fmla="*/ 1166371 h 197624"/>
              <a:gd name="T22" fmla="*/ 12335 w 378471"/>
              <a:gd name="T23" fmla="*/ 1260948 h 197624"/>
              <a:gd name="T24" fmla="*/ 16436 w 378471"/>
              <a:gd name="T25" fmla="*/ 1292467 h 197624"/>
              <a:gd name="T26" fmla="*/ 32845 w 378471"/>
              <a:gd name="T27" fmla="*/ 1355519 h 197624"/>
              <a:gd name="T28" fmla="*/ 65663 w 378471"/>
              <a:gd name="T29" fmla="*/ 1387033 h 197624"/>
              <a:gd name="T30" fmla="*/ 108051 w 378471"/>
              <a:gd name="T31" fmla="*/ 1418557 h 197624"/>
              <a:gd name="T32" fmla="*/ 116256 w 378471"/>
              <a:gd name="T33" fmla="*/ 1166371 h 197624"/>
              <a:gd name="T34" fmla="*/ 121725 w 378471"/>
              <a:gd name="T35" fmla="*/ 914187 h 197624"/>
              <a:gd name="T36" fmla="*/ 120358 w 378471"/>
              <a:gd name="T37" fmla="*/ 567418 h 197624"/>
              <a:gd name="T38" fmla="*/ 108051 w 378471"/>
              <a:gd name="T39" fmla="*/ 598953 h 197624"/>
              <a:gd name="T40" fmla="*/ 99848 w 378471"/>
              <a:gd name="T41" fmla="*/ 661992 h 197624"/>
              <a:gd name="T42" fmla="*/ 84806 w 378471"/>
              <a:gd name="T43" fmla="*/ 725041 h 197624"/>
              <a:gd name="T44" fmla="*/ 83438 w 378471"/>
              <a:gd name="T45" fmla="*/ 630476 h 197624"/>
              <a:gd name="T46" fmla="*/ 80703 w 378471"/>
              <a:gd name="T47" fmla="*/ 157619 h 197624"/>
              <a:gd name="T48" fmla="*/ 79336 w 378471"/>
              <a:gd name="T49" fmla="*/ 63048 h 197624"/>
              <a:gd name="T50" fmla="*/ 75234 w 378471"/>
              <a:gd name="T51" fmla="*/ 0 h 197624"/>
              <a:gd name="T52" fmla="*/ 65663 w 378471"/>
              <a:gd name="T53" fmla="*/ 31526 h 197624"/>
              <a:gd name="T54" fmla="*/ 57458 w 378471"/>
              <a:gd name="T55" fmla="*/ 409808 h 197624"/>
              <a:gd name="T56" fmla="*/ 64296 w 378471"/>
              <a:gd name="T57" fmla="*/ 472854 h 197624"/>
              <a:gd name="T58" fmla="*/ 0 60000 65536"/>
              <a:gd name="T59" fmla="*/ 0 60000 65536"/>
              <a:gd name="T60" fmla="*/ 0 60000 65536"/>
              <a:gd name="T61" fmla="*/ 0 60000 65536"/>
              <a:gd name="T62" fmla="*/ 0 60000 65536"/>
              <a:gd name="T63" fmla="*/ 0 60000 65536"/>
              <a:gd name="T64" fmla="*/ 0 60000 65536"/>
              <a:gd name="T65" fmla="*/ 0 60000 65536"/>
              <a:gd name="T66" fmla="*/ 0 60000 65536"/>
              <a:gd name="T67" fmla="*/ 0 60000 65536"/>
              <a:gd name="T68" fmla="*/ 0 60000 65536"/>
              <a:gd name="T69" fmla="*/ 0 60000 65536"/>
              <a:gd name="T70" fmla="*/ 0 60000 65536"/>
              <a:gd name="T71" fmla="*/ 0 60000 65536"/>
              <a:gd name="T72" fmla="*/ 0 60000 65536"/>
              <a:gd name="T73" fmla="*/ 0 60000 65536"/>
              <a:gd name="T74" fmla="*/ 0 60000 65536"/>
              <a:gd name="T75" fmla="*/ 0 60000 65536"/>
              <a:gd name="T76" fmla="*/ 0 60000 65536"/>
              <a:gd name="T77" fmla="*/ 0 60000 65536"/>
              <a:gd name="T78" fmla="*/ 0 60000 65536"/>
              <a:gd name="T79" fmla="*/ 0 60000 65536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</a:gdLst>
            <a:ahLst/>
            <a:cxnLst>
              <a:cxn ang="T58">
                <a:pos x="T0" y="T1"/>
              </a:cxn>
              <a:cxn ang="T59">
                <a:pos x="T2" y="T3"/>
              </a:cxn>
              <a:cxn ang="T60">
                <a:pos x="T4" y="T5"/>
              </a:cxn>
              <a:cxn ang="T61">
                <a:pos x="T6" y="T7"/>
              </a:cxn>
              <a:cxn ang="T62">
                <a:pos x="T8" y="T9"/>
              </a:cxn>
              <a:cxn ang="T63">
                <a:pos x="T10" y="T11"/>
              </a:cxn>
              <a:cxn ang="T64">
                <a:pos x="T12" y="T13"/>
              </a:cxn>
              <a:cxn ang="T65">
                <a:pos x="T14" y="T15"/>
              </a:cxn>
              <a:cxn ang="T66">
                <a:pos x="T16" y="T17"/>
              </a:cxn>
              <a:cxn ang="T67">
                <a:pos x="T18" y="T19"/>
              </a:cxn>
              <a:cxn ang="T68">
                <a:pos x="T20" y="T21"/>
              </a:cxn>
              <a:cxn ang="T69">
                <a:pos x="T22" y="T23"/>
              </a:cxn>
              <a:cxn ang="T70">
                <a:pos x="T24" y="T25"/>
              </a:cxn>
              <a:cxn ang="T71">
                <a:pos x="T26" y="T27"/>
              </a:cxn>
              <a:cxn ang="T72">
                <a:pos x="T28" y="T29"/>
              </a:cxn>
              <a:cxn ang="T73">
                <a:pos x="T30" y="T31"/>
              </a:cxn>
              <a:cxn ang="T74">
                <a:pos x="T32" y="T33"/>
              </a:cxn>
              <a:cxn ang="T75">
                <a:pos x="T34" y="T35"/>
              </a:cxn>
              <a:cxn ang="T76">
                <a:pos x="T36" y="T37"/>
              </a:cxn>
              <a:cxn ang="T77">
                <a:pos x="T38" y="T39"/>
              </a:cxn>
              <a:cxn ang="T78">
                <a:pos x="T40" y="T41"/>
              </a:cxn>
              <a:cxn ang="T79">
                <a:pos x="T42" y="T43"/>
              </a:cxn>
              <a:cxn ang="T80">
                <a:pos x="T44" y="T45"/>
              </a:cxn>
              <a:cxn ang="T81">
                <a:pos x="T46" y="T47"/>
              </a:cxn>
              <a:cxn ang="T82">
                <a:pos x="T48" y="T49"/>
              </a:cxn>
              <a:cxn ang="T83">
                <a:pos x="T50" y="T51"/>
              </a:cxn>
              <a:cxn ang="T84">
                <a:pos x="T52" y="T53"/>
              </a:cxn>
              <a:cxn ang="T85">
                <a:pos x="T54" y="T55"/>
              </a:cxn>
              <a:cxn ang="T86">
                <a:pos x="T56" y="T57"/>
              </a:cxn>
            </a:cxnLst>
            <a:rect l="0" t="0" r="r" b="b"/>
            <a:pathLst>
              <a:path w="378471" h="197624">
                <a:moveTo>
                  <a:pt x="199054" y="63500"/>
                </a:moveTo>
                <a:lnTo>
                  <a:pt x="199054" y="63500"/>
                </a:lnTo>
                <a:cubicBezTo>
                  <a:pt x="156721" y="62089"/>
                  <a:pt x="114265" y="62785"/>
                  <a:pt x="72054" y="59267"/>
                </a:cubicBezTo>
                <a:cubicBezTo>
                  <a:pt x="63160" y="58526"/>
                  <a:pt x="46654" y="50800"/>
                  <a:pt x="46654" y="50800"/>
                </a:cubicBezTo>
                <a:cubicBezTo>
                  <a:pt x="32543" y="52211"/>
                  <a:pt x="17231" y="49166"/>
                  <a:pt x="4320" y="55034"/>
                </a:cubicBezTo>
                <a:cubicBezTo>
                  <a:pt x="-977" y="57442"/>
                  <a:pt x="87" y="66149"/>
                  <a:pt x="87" y="71967"/>
                </a:cubicBezTo>
                <a:cubicBezTo>
                  <a:pt x="87" y="76429"/>
                  <a:pt x="2153" y="80766"/>
                  <a:pt x="4320" y="84667"/>
                </a:cubicBezTo>
                <a:cubicBezTo>
                  <a:pt x="9262" y="93562"/>
                  <a:pt x="21254" y="110067"/>
                  <a:pt x="21254" y="110067"/>
                </a:cubicBezTo>
                <a:cubicBezTo>
                  <a:pt x="22665" y="114300"/>
                  <a:pt x="22332" y="119612"/>
                  <a:pt x="25487" y="122767"/>
                </a:cubicBezTo>
                <a:cubicBezTo>
                  <a:pt x="32682" y="129962"/>
                  <a:pt x="50887" y="139700"/>
                  <a:pt x="50887" y="139700"/>
                </a:cubicBezTo>
                <a:cubicBezTo>
                  <a:pt x="49476" y="145345"/>
                  <a:pt x="48946" y="151286"/>
                  <a:pt x="46654" y="156634"/>
                </a:cubicBezTo>
                <a:cubicBezTo>
                  <a:pt x="44650" y="161311"/>
                  <a:pt x="36953" y="164398"/>
                  <a:pt x="38187" y="169334"/>
                </a:cubicBezTo>
                <a:cubicBezTo>
                  <a:pt x="39269" y="173663"/>
                  <a:pt x="46511" y="172692"/>
                  <a:pt x="50887" y="173567"/>
                </a:cubicBezTo>
                <a:cubicBezTo>
                  <a:pt x="67721" y="176934"/>
                  <a:pt x="84535" y="181319"/>
                  <a:pt x="101687" y="182034"/>
                </a:cubicBezTo>
                <a:lnTo>
                  <a:pt x="203287" y="186267"/>
                </a:lnTo>
                <a:cubicBezTo>
                  <a:pt x="262181" y="205899"/>
                  <a:pt x="219769" y="195091"/>
                  <a:pt x="334520" y="190500"/>
                </a:cubicBezTo>
                <a:cubicBezTo>
                  <a:pt x="350486" y="174534"/>
                  <a:pt x="347647" y="179427"/>
                  <a:pt x="359920" y="156634"/>
                </a:cubicBezTo>
                <a:cubicBezTo>
                  <a:pt x="365904" y="145521"/>
                  <a:pt x="376854" y="122767"/>
                  <a:pt x="376854" y="122767"/>
                </a:cubicBezTo>
                <a:cubicBezTo>
                  <a:pt x="375443" y="107245"/>
                  <a:pt x="383641" y="87221"/>
                  <a:pt x="372620" y="76200"/>
                </a:cubicBezTo>
                <a:cubicBezTo>
                  <a:pt x="363584" y="67165"/>
                  <a:pt x="347050" y="77928"/>
                  <a:pt x="334520" y="80434"/>
                </a:cubicBezTo>
                <a:cubicBezTo>
                  <a:pt x="325769" y="82184"/>
                  <a:pt x="309120" y="88900"/>
                  <a:pt x="309120" y="88900"/>
                </a:cubicBezTo>
                <a:cubicBezTo>
                  <a:pt x="293008" y="105012"/>
                  <a:pt x="293557" y="111146"/>
                  <a:pt x="262554" y="97367"/>
                </a:cubicBezTo>
                <a:cubicBezTo>
                  <a:pt x="258476" y="95555"/>
                  <a:pt x="259731" y="88900"/>
                  <a:pt x="258320" y="84667"/>
                </a:cubicBezTo>
                <a:cubicBezTo>
                  <a:pt x="254992" y="48060"/>
                  <a:pt x="257332" y="47340"/>
                  <a:pt x="249854" y="21167"/>
                </a:cubicBezTo>
                <a:cubicBezTo>
                  <a:pt x="248628" y="16876"/>
                  <a:pt x="248408" y="11952"/>
                  <a:pt x="245620" y="8467"/>
                </a:cubicBezTo>
                <a:cubicBezTo>
                  <a:pt x="242442" y="4494"/>
                  <a:pt x="237153" y="2822"/>
                  <a:pt x="232920" y="0"/>
                </a:cubicBezTo>
                <a:cubicBezTo>
                  <a:pt x="223042" y="1411"/>
                  <a:pt x="211163" y="-1892"/>
                  <a:pt x="203287" y="4234"/>
                </a:cubicBezTo>
                <a:cubicBezTo>
                  <a:pt x="195235" y="10497"/>
                  <a:pt x="195629" y="55034"/>
                  <a:pt x="177887" y="55034"/>
                </a:cubicBezTo>
                <a:lnTo>
                  <a:pt x="199054" y="63500"/>
                </a:lnTo>
                <a:close/>
              </a:path>
            </a:pathLst>
          </a:custGeom>
          <a:solidFill>
            <a:srgbClr val="FFFFFF"/>
          </a:solidFill>
          <a:ln w="12700" cap="flat" cmpd="sng">
            <a:solidFill>
              <a:srgbClr val="000000"/>
            </a:solidFill>
            <a:prstDash val="solid"/>
            <a:round/>
            <a:headEnd/>
            <a:tailEnd/>
          </a:ln>
          <a:effectLst>
            <a:outerShdw blurRad="40000" dist="23000" dir="5400000" rotWithShape="0">
              <a:srgbClr val="000000">
                <a:alpha val="34998"/>
              </a:srgbClr>
            </a:outerShdw>
          </a:effectLst>
        </p:spPr>
        <p:txBody>
          <a:bodyPr lIns="81638" tIns="40819" rIns="81638" bIns="40819" anchor="ctr"/>
          <a:lstStyle/>
          <a:p>
            <a:pPr>
              <a:defRPr/>
            </a:pPr>
            <a:endParaRPr lang="en-US"/>
          </a:p>
        </p:txBody>
      </p:sp>
      <p:sp>
        <p:nvSpPr>
          <p:cNvPr id="38" name="TextBox 36"/>
          <p:cNvSpPr txBox="1">
            <a:spLocks noChangeArrowheads="1"/>
          </p:cNvSpPr>
          <p:nvPr/>
        </p:nvSpPr>
        <p:spPr bwMode="auto">
          <a:xfrm>
            <a:off x="2155825" y="2288381"/>
            <a:ext cx="4827588" cy="360363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chemeClr val="bg1"/>
                </a:solidFill>
                <a:cs typeface="Arial" charset="0"/>
              </a:rPr>
              <a:t>Computerized Tumor Segmentation</a:t>
            </a:r>
          </a:p>
        </p:txBody>
      </p:sp>
      <p:sp>
        <p:nvSpPr>
          <p:cNvPr id="39" name="TextBox 37"/>
          <p:cNvSpPr txBox="1">
            <a:spLocks noChangeArrowheads="1"/>
          </p:cNvSpPr>
          <p:nvPr/>
        </p:nvSpPr>
        <p:spPr bwMode="auto">
          <a:xfrm>
            <a:off x="2101850" y="1637506"/>
            <a:ext cx="4900613" cy="358775"/>
          </a:xfrm>
          <a:prstGeom prst="rect">
            <a:avLst/>
          </a:prstGeom>
          <a:solidFill>
            <a:srgbClr val="0000FF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lIns="81638" tIns="40819" rIns="81638" bIns="408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800">
                <a:solidFill>
                  <a:schemeClr val="bg1"/>
                </a:solidFill>
                <a:cs typeface="Arial" charset="0"/>
              </a:rPr>
              <a:t>Radiologist-indicated Tumor Center</a:t>
            </a:r>
          </a:p>
        </p:txBody>
      </p:sp>
      <p:cxnSp>
        <p:nvCxnSpPr>
          <p:cNvPr id="40" name="Straight Arrow Connector 39"/>
          <p:cNvCxnSpPr/>
          <p:nvPr/>
        </p:nvCxnSpPr>
        <p:spPr>
          <a:xfrm flipH="1">
            <a:off x="4570413" y="2008981"/>
            <a:ext cx="9525" cy="31591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>
            <a:off x="4584700" y="1250156"/>
            <a:ext cx="0" cy="38735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Oval 125"/>
          <p:cNvSpPr>
            <a:spLocks noChangeAspect="1" noChangeArrowheads="1"/>
          </p:cNvSpPr>
          <p:nvPr/>
        </p:nvSpPr>
        <p:spPr bwMode="auto">
          <a:xfrm>
            <a:off x="3436938" y="4333081"/>
            <a:ext cx="315912" cy="347663"/>
          </a:xfrm>
          <a:prstGeom prst="ellipse">
            <a:avLst/>
          </a:prstGeom>
          <a:solidFill>
            <a:srgbClr val="008000"/>
          </a:solidFill>
          <a:ln w="38100">
            <a:solidFill>
              <a:srgbClr val="000000"/>
            </a:solidFill>
            <a:round/>
            <a:headEnd/>
            <a:tailEnd/>
          </a:ln>
        </p:spPr>
        <p:txBody>
          <a:bodyPr wrap="none" lIns="81638" tIns="40819" rIns="81638" bIns="40819" anchor="ctr"/>
          <a:lstStyle/>
          <a:p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43" name="AutoShape 126"/>
          <p:cNvSpPr>
            <a:spLocks noChangeAspect="1" noChangeArrowheads="1"/>
          </p:cNvSpPr>
          <p:nvPr/>
        </p:nvSpPr>
        <p:spPr bwMode="auto">
          <a:xfrm>
            <a:off x="3970338" y="4256881"/>
            <a:ext cx="361950" cy="455613"/>
          </a:xfrm>
          <a:prstGeom prst="irregularSeal1">
            <a:avLst/>
          </a:prstGeom>
          <a:solidFill>
            <a:srgbClr val="FF0000"/>
          </a:solidFill>
          <a:ln w="38100">
            <a:solidFill>
              <a:srgbClr val="000000"/>
            </a:solidFill>
            <a:miter lim="800000"/>
            <a:headEnd/>
            <a:tailEnd/>
          </a:ln>
        </p:spPr>
        <p:txBody>
          <a:bodyPr wrap="none" lIns="81638" tIns="40819" rIns="81638" bIns="40819" anchor="ctr"/>
          <a:lstStyle/>
          <a:p>
            <a:endParaRPr lang="en-US">
              <a:solidFill>
                <a:srgbClr val="FFFFFF"/>
              </a:solidFill>
              <a:cs typeface="Arial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2057" y="41681"/>
            <a:ext cx="22886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/>
              <a:t>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3459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33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arvard Medical Scho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</dc:title>
  <dc:creator>Albert Yeh</dc:creator>
  <cp:lastModifiedBy>Albert Yeh</cp:lastModifiedBy>
  <cp:revision>8</cp:revision>
  <dcterms:created xsi:type="dcterms:W3CDTF">2016-05-28T19:49:17Z</dcterms:created>
  <dcterms:modified xsi:type="dcterms:W3CDTF">2016-08-08T01:51:42Z</dcterms:modified>
</cp:coreProperties>
</file>